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15" autoAdjust="0"/>
    <p:restoredTop sz="94660"/>
  </p:normalViewPr>
  <p:slideViewPr>
    <p:cSldViewPr snapToGrid="0">
      <p:cViewPr varScale="1">
        <p:scale>
          <a:sx n="75" d="100"/>
          <a:sy n="75" d="100"/>
        </p:scale>
        <p:origin x="25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P Andersson" userId="5d16bd0d-49f7-429a-8892-0eda668602a9" providerId="ADAL" clId="{809CD3F4-7EED-42B3-9593-166E952238D3}"/>
    <pc:docChg chg="undo custSel addSld delSld modSld">
      <pc:chgData name="Daniel P Andersson" userId="5d16bd0d-49f7-429a-8892-0eda668602a9" providerId="ADAL" clId="{809CD3F4-7EED-42B3-9593-166E952238D3}" dt="2025-01-16T10:29:12.716" v="71" actId="20577"/>
      <pc:docMkLst>
        <pc:docMk/>
      </pc:docMkLst>
      <pc:sldChg chg="modSp mod">
        <pc:chgData name="Daniel P Andersson" userId="5d16bd0d-49f7-429a-8892-0eda668602a9" providerId="ADAL" clId="{809CD3F4-7EED-42B3-9593-166E952238D3}" dt="2025-01-16T10:29:12.716" v="71" actId="20577"/>
        <pc:sldMkLst>
          <pc:docMk/>
          <pc:sldMk cId="1707854392" sldId="256"/>
        </pc:sldMkLst>
        <pc:spChg chg="mod">
          <ac:chgData name="Daniel P Andersson" userId="5d16bd0d-49f7-429a-8892-0eda668602a9" providerId="ADAL" clId="{809CD3F4-7EED-42B3-9593-166E952238D3}" dt="2024-12-28T10:00:47.006" v="26" actId="6549"/>
          <ac:spMkLst>
            <pc:docMk/>
            <pc:sldMk cId="1707854392" sldId="256"/>
            <ac:spMk id="8" creationId="{9B4093C9-348C-A8F9-F08E-86AF502B8536}"/>
          </ac:spMkLst>
        </pc:spChg>
        <pc:spChg chg="mod">
          <ac:chgData name="Daniel P Andersson" userId="5d16bd0d-49f7-429a-8892-0eda668602a9" providerId="ADAL" clId="{809CD3F4-7EED-42B3-9593-166E952238D3}" dt="2024-12-28T10:02:02.573" v="34" actId="1076"/>
          <ac:spMkLst>
            <pc:docMk/>
            <pc:sldMk cId="1707854392" sldId="256"/>
            <ac:spMk id="9" creationId="{D30332D2-57AD-9DE7-F87E-3C8EA711874E}"/>
          </ac:spMkLst>
        </pc:spChg>
        <pc:spChg chg="mod">
          <ac:chgData name="Daniel P Andersson" userId="5d16bd0d-49f7-429a-8892-0eda668602a9" providerId="ADAL" clId="{809CD3F4-7EED-42B3-9593-166E952238D3}" dt="2024-12-28T10:01:29.823" v="32" actId="1076"/>
          <ac:spMkLst>
            <pc:docMk/>
            <pc:sldMk cId="1707854392" sldId="256"/>
            <ac:spMk id="20" creationId="{565820A5-BF89-D550-DF3D-2DAA842767FD}"/>
          </ac:spMkLst>
        </pc:spChg>
        <pc:spChg chg="mod">
          <ac:chgData name="Daniel P Andersson" userId="5d16bd0d-49f7-429a-8892-0eda668602a9" providerId="ADAL" clId="{809CD3F4-7EED-42B3-9593-166E952238D3}" dt="2024-12-28T10:01:11.373" v="30" actId="14100"/>
          <ac:spMkLst>
            <pc:docMk/>
            <pc:sldMk cId="1707854392" sldId="256"/>
            <ac:spMk id="21" creationId="{0E1F5F36-D9EC-16BD-30E1-F878D2F51D32}"/>
          </ac:spMkLst>
        </pc:spChg>
        <pc:spChg chg="mod">
          <ac:chgData name="Daniel P Andersson" userId="5d16bd0d-49f7-429a-8892-0eda668602a9" providerId="ADAL" clId="{809CD3F4-7EED-42B3-9593-166E952238D3}" dt="2024-12-28T10:01:37.842" v="33" actId="1076"/>
          <ac:spMkLst>
            <pc:docMk/>
            <pc:sldMk cId="1707854392" sldId="256"/>
            <ac:spMk id="23" creationId="{0F36B1A3-E864-1C0D-5937-F97B8E5881C1}"/>
          </ac:spMkLst>
        </pc:spChg>
        <pc:spChg chg="mod">
          <ac:chgData name="Daniel P Andersson" userId="5d16bd0d-49f7-429a-8892-0eda668602a9" providerId="ADAL" clId="{809CD3F4-7EED-42B3-9593-166E952238D3}" dt="2024-12-28T10:01:14.494" v="31" actId="14100"/>
          <ac:spMkLst>
            <pc:docMk/>
            <pc:sldMk cId="1707854392" sldId="256"/>
            <ac:spMk id="24" creationId="{4B80FDA4-7D52-C85B-D4B8-2A1F5190083F}"/>
          </ac:spMkLst>
        </pc:spChg>
        <pc:spChg chg="mod">
          <ac:chgData name="Daniel P Andersson" userId="5d16bd0d-49f7-429a-8892-0eda668602a9" providerId="ADAL" clId="{809CD3F4-7EED-42B3-9593-166E952238D3}" dt="2024-12-28T10:03:40.507" v="50" actId="1076"/>
          <ac:spMkLst>
            <pc:docMk/>
            <pc:sldMk cId="1707854392" sldId="256"/>
            <ac:spMk id="26" creationId="{399A0715-4849-E7C1-500A-40166A096396}"/>
          </ac:spMkLst>
        </pc:spChg>
        <pc:spChg chg="mod">
          <ac:chgData name="Daniel P Andersson" userId="5d16bd0d-49f7-429a-8892-0eda668602a9" providerId="ADAL" clId="{809CD3F4-7EED-42B3-9593-166E952238D3}" dt="2024-12-28T10:03:27.506" v="47" actId="1076"/>
          <ac:spMkLst>
            <pc:docMk/>
            <pc:sldMk cId="1707854392" sldId="256"/>
            <ac:spMk id="28" creationId="{6EA6837D-5F57-2B05-763E-24B6CBDC2916}"/>
          </ac:spMkLst>
        </pc:spChg>
        <pc:spChg chg="mod">
          <ac:chgData name="Daniel P Andersson" userId="5d16bd0d-49f7-429a-8892-0eda668602a9" providerId="ADAL" clId="{809CD3F4-7EED-42B3-9593-166E952238D3}" dt="2025-01-16T10:29:12.716" v="71" actId="20577"/>
          <ac:spMkLst>
            <pc:docMk/>
            <pc:sldMk cId="1707854392" sldId="256"/>
            <ac:spMk id="29" creationId="{2059A457-8E37-0CA0-6481-F6A2F6EC99E1}"/>
          </ac:spMkLst>
        </pc:spChg>
        <pc:spChg chg="mod">
          <ac:chgData name="Daniel P Andersson" userId="5d16bd0d-49f7-429a-8892-0eda668602a9" providerId="ADAL" clId="{809CD3F4-7EED-42B3-9593-166E952238D3}" dt="2025-01-16T10:28:46.617" v="64" actId="6549"/>
          <ac:spMkLst>
            <pc:docMk/>
            <pc:sldMk cId="1707854392" sldId="256"/>
            <ac:spMk id="34" creationId="{D87CDE1E-0661-3DC5-BD8F-01E3438A47FC}"/>
          </ac:spMkLst>
        </pc:spChg>
      </pc:sldChg>
      <pc:sldChg chg="addSp delSp modSp new del mod">
        <pc:chgData name="Daniel P Andersson" userId="5d16bd0d-49f7-429a-8892-0eda668602a9" providerId="ADAL" clId="{809CD3F4-7EED-42B3-9593-166E952238D3}" dt="2024-12-28T10:00:41.910" v="25" actId="680"/>
        <pc:sldMkLst>
          <pc:docMk/>
          <pc:sldMk cId="1427235551" sldId="257"/>
        </pc:sldMkLst>
      </pc:sldChg>
    </pc:docChg>
  </pc:docChgLst>
  <pc:docChgLst>
    <pc:chgData name="Daniel P Andersson" userId="5d16bd0d-49f7-429a-8892-0eda668602a9" providerId="ADAL" clId="{A487C41D-16B4-420B-AEC1-AC768CE32DDE}"/>
    <pc:docChg chg="custSel modSld">
      <pc:chgData name="Daniel P Andersson" userId="5d16bd0d-49f7-429a-8892-0eda668602a9" providerId="ADAL" clId="{A487C41D-16B4-420B-AEC1-AC768CE32DDE}" dt="2025-01-22T13:26:38.725" v="0" actId="478"/>
      <pc:docMkLst>
        <pc:docMk/>
      </pc:docMkLst>
      <pc:sldChg chg="delSp mod">
        <pc:chgData name="Daniel P Andersson" userId="5d16bd0d-49f7-429a-8892-0eda668602a9" providerId="ADAL" clId="{A487C41D-16B4-420B-AEC1-AC768CE32DDE}" dt="2025-01-22T13:26:38.725" v="0" actId="478"/>
        <pc:sldMkLst>
          <pc:docMk/>
          <pc:sldMk cId="1707854392" sldId="256"/>
        </pc:sldMkLst>
        <pc:spChg chg="del">
          <ac:chgData name="Daniel P Andersson" userId="5d16bd0d-49f7-429a-8892-0eda668602a9" providerId="ADAL" clId="{A487C41D-16B4-420B-AEC1-AC768CE32DDE}" dt="2025-01-22T13:26:38.725" v="0" actId="478"/>
          <ac:spMkLst>
            <pc:docMk/>
            <pc:sldMk cId="1707854392" sldId="256"/>
            <ac:spMk id="4" creationId="{B403AA34-F202-BADA-2987-1B096C6D69EE}"/>
          </ac:spMkLst>
        </pc:spChg>
      </pc:sldChg>
    </pc:docChg>
  </pc:docChgLst>
  <pc:docChgLst>
    <pc:chgData name="Peter Arner" userId="3fe2d872-2352-4a38-a10b-f5d5b2230715" providerId="ADAL" clId="{E0209236-D0DA-46AC-9428-03F54B6E0F0E}"/>
    <pc:docChg chg="custSel modSld">
      <pc:chgData name="Peter Arner" userId="3fe2d872-2352-4a38-a10b-f5d5b2230715" providerId="ADAL" clId="{E0209236-D0DA-46AC-9428-03F54B6E0F0E}" dt="2024-12-12T14:17:42.113" v="233" actId="20577"/>
      <pc:docMkLst>
        <pc:docMk/>
      </pc:docMkLst>
      <pc:sldChg chg="addSp modSp mod">
        <pc:chgData name="Peter Arner" userId="3fe2d872-2352-4a38-a10b-f5d5b2230715" providerId="ADAL" clId="{E0209236-D0DA-46AC-9428-03F54B6E0F0E}" dt="2024-12-12T14:17:42.113" v="233" actId="20577"/>
        <pc:sldMkLst>
          <pc:docMk/>
          <pc:sldMk cId="1707854392" sldId="256"/>
        </pc:sldMkLst>
        <pc:spChg chg="mod">
          <ac:chgData name="Peter Arner" userId="3fe2d872-2352-4a38-a10b-f5d5b2230715" providerId="ADAL" clId="{E0209236-D0DA-46AC-9428-03F54B6E0F0E}" dt="2024-12-10T14:33:43.113" v="89" actId="20577"/>
          <ac:spMkLst>
            <pc:docMk/>
            <pc:sldMk cId="1707854392" sldId="256"/>
            <ac:spMk id="7" creationId="{25F7AB6B-339A-64D6-4706-F8762EF6CB72}"/>
          </ac:spMkLst>
        </pc:spChg>
        <pc:spChg chg="mod">
          <ac:chgData name="Peter Arner" userId="3fe2d872-2352-4a38-a10b-f5d5b2230715" providerId="ADAL" clId="{E0209236-D0DA-46AC-9428-03F54B6E0F0E}" dt="2024-12-12T14:16:42.620" v="229" actId="20577"/>
          <ac:spMkLst>
            <pc:docMk/>
            <pc:sldMk cId="1707854392" sldId="256"/>
            <ac:spMk id="8" creationId="{9B4093C9-348C-A8F9-F08E-86AF502B8536}"/>
          </ac:spMkLst>
        </pc:spChg>
        <pc:spChg chg="mod">
          <ac:chgData name="Peter Arner" userId="3fe2d872-2352-4a38-a10b-f5d5b2230715" providerId="ADAL" clId="{E0209236-D0DA-46AC-9428-03F54B6E0F0E}" dt="2024-12-10T14:33:48.262" v="91" actId="20577"/>
          <ac:spMkLst>
            <pc:docMk/>
            <pc:sldMk cId="1707854392" sldId="256"/>
            <ac:spMk id="9" creationId="{D30332D2-57AD-9DE7-F87E-3C8EA711874E}"/>
          </ac:spMkLst>
        </pc:spChg>
        <pc:spChg chg="mod">
          <ac:chgData name="Peter Arner" userId="3fe2d872-2352-4a38-a10b-f5d5b2230715" providerId="ADAL" clId="{E0209236-D0DA-46AC-9428-03F54B6E0F0E}" dt="2024-12-10T14:41:34.749" v="101" actId="20577"/>
          <ac:spMkLst>
            <pc:docMk/>
            <pc:sldMk cId="1707854392" sldId="256"/>
            <ac:spMk id="15" creationId="{9658CC0C-4D37-EEA8-228B-A0AEEF93E32E}"/>
          </ac:spMkLst>
        </pc:spChg>
        <pc:spChg chg="mod">
          <ac:chgData name="Peter Arner" userId="3fe2d872-2352-4a38-a10b-f5d5b2230715" providerId="ADAL" clId="{E0209236-D0DA-46AC-9428-03F54B6E0F0E}" dt="2024-12-10T14:42:42.229" v="107" actId="20577"/>
          <ac:spMkLst>
            <pc:docMk/>
            <pc:sldMk cId="1707854392" sldId="256"/>
            <ac:spMk id="18" creationId="{876EB3AB-C48E-8A4F-4490-F918C2C29525}"/>
          </ac:spMkLst>
        </pc:spChg>
        <pc:spChg chg="mod">
          <ac:chgData name="Peter Arner" userId="3fe2d872-2352-4a38-a10b-f5d5b2230715" providerId="ADAL" clId="{E0209236-D0DA-46AC-9428-03F54B6E0F0E}" dt="2024-12-10T14:43:28.489" v="110" actId="164"/>
          <ac:spMkLst>
            <pc:docMk/>
            <pc:sldMk cId="1707854392" sldId="256"/>
            <ac:spMk id="25" creationId="{51390AE3-AAD6-F91D-C1A1-3054F04B916C}"/>
          </ac:spMkLst>
        </pc:spChg>
        <pc:spChg chg="add mod">
          <ac:chgData name="Peter Arner" userId="3fe2d872-2352-4a38-a10b-f5d5b2230715" providerId="ADAL" clId="{E0209236-D0DA-46AC-9428-03F54B6E0F0E}" dt="2024-12-10T14:52:13.046" v="116" actId="1076"/>
          <ac:spMkLst>
            <pc:docMk/>
            <pc:sldMk cId="1707854392" sldId="256"/>
            <ac:spMk id="26" creationId="{399A0715-4849-E7C1-500A-40166A096396}"/>
          </ac:spMkLst>
        </pc:spChg>
        <pc:spChg chg="mod">
          <ac:chgData name="Peter Arner" userId="3fe2d872-2352-4a38-a10b-f5d5b2230715" providerId="ADAL" clId="{E0209236-D0DA-46AC-9428-03F54B6E0F0E}" dt="2024-12-10T14:52:10.339" v="115" actId="1076"/>
          <ac:spMkLst>
            <pc:docMk/>
            <pc:sldMk cId="1707854392" sldId="256"/>
            <ac:spMk id="28" creationId="{6EA6837D-5F57-2B05-763E-24B6CBDC2916}"/>
          </ac:spMkLst>
        </pc:spChg>
        <pc:spChg chg="add mod">
          <ac:chgData name="Peter Arner" userId="3fe2d872-2352-4a38-a10b-f5d5b2230715" providerId="ADAL" clId="{E0209236-D0DA-46AC-9428-03F54B6E0F0E}" dt="2024-12-10T14:52:17.643" v="117" actId="1076"/>
          <ac:spMkLst>
            <pc:docMk/>
            <pc:sldMk cId="1707854392" sldId="256"/>
            <ac:spMk id="29" creationId="{2059A457-8E37-0CA0-6481-F6A2F6EC99E1}"/>
          </ac:spMkLst>
        </pc:spChg>
        <pc:spChg chg="add mod">
          <ac:chgData name="Peter Arner" userId="3fe2d872-2352-4a38-a10b-f5d5b2230715" providerId="ADAL" clId="{E0209236-D0DA-46AC-9428-03F54B6E0F0E}" dt="2024-12-10T14:55:40.957" v="127" actId="1076"/>
          <ac:spMkLst>
            <pc:docMk/>
            <pc:sldMk cId="1707854392" sldId="256"/>
            <ac:spMk id="32" creationId="{6421E6EA-5E8F-E9C4-94E2-13027DC024CE}"/>
          </ac:spMkLst>
        </pc:spChg>
        <pc:spChg chg="add mod">
          <ac:chgData name="Peter Arner" userId="3fe2d872-2352-4a38-a10b-f5d5b2230715" providerId="ADAL" clId="{E0209236-D0DA-46AC-9428-03F54B6E0F0E}" dt="2024-12-10T14:58:30.608" v="199" actId="164"/>
          <ac:spMkLst>
            <pc:docMk/>
            <pc:sldMk cId="1707854392" sldId="256"/>
            <ac:spMk id="33" creationId="{D7B2BB63-139D-529B-64C7-85003875B96F}"/>
          </ac:spMkLst>
        </pc:spChg>
        <pc:spChg chg="add mod">
          <ac:chgData name="Peter Arner" userId="3fe2d872-2352-4a38-a10b-f5d5b2230715" providerId="ADAL" clId="{E0209236-D0DA-46AC-9428-03F54B6E0F0E}" dt="2024-12-10T14:59:27.305" v="200" actId="20577"/>
          <ac:spMkLst>
            <pc:docMk/>
            <pc:sldMk cId="1707854392" sldId="256"/>
            <ac:spMk id="34" creationId="{D87CDE1E-0661-3DC5-BD8F-01E3438A47FC}"/>
          </ac:spMkLst>
        </pc:spChg>
        <pc:grpChg chg="add mod">
          <ac:chgData name="Peter Arner" userId="3fe2d872-2352-4a38-a10b-f5d5b2230715" providerId="ADAL" clId="{E0209236-D0DA-46AC-9428-03F54B6E0F0E}" dt="2024-12-10T14:29:40.555" v="3" actId="1076"/>
          <ac:grpSpMkLst>
            <pc:docMk/>
            <pc:sldMk cId="1707854392" sldId="256"/>
            <ac:grpSpMk id="2" creationId="{A1BD9681-7FD6-8199-6AF5-466741EFFEE2}"/>
          </ac:grpSpMkLst>
        </pc:grpChg>
        <pc:grpChg chg="mod">
          <ac:chgData name="Peter Arner" userId="3fe2d872-2352-4a38-a10b-f5d5b2230715" providerId="ADAL" clId="{E0209236-D0DA-46AC-9428-03F54B6E0F0E}" dt="2024-12-10T14:29:33.354" v="2" actId="164"/>
          <ac:grpSpMkLst>
            <pc:docMk/>
            <pc:sldMk cId="1707854392" sldId="256"/>
            <ac:grpSpMk id="12" creationId="{F3502025-4E0E-F060-B80A-64242423D791}"/>
          </ac:grpSpMkLst>
        </pc:grpChg>
        <pc:grpChg chg="mod">
          <ac:chgData name="Peter Arner" userId="3fe2d872-2352-4a38-a10b-f5d5b2230715" providerId="ADAL" clId="{E0209236-D0DA-46AC-9428-03F54B6E0F0E}" dt="2024-12-10T14:29:33.354" v="2" actId="164"/>
          <ac:grpSpMkLst>
            <pc:docMk/>
            <pc:sldMk cId="1707854392" sldId="256"/>
            <ac:grpSpMk id="13" creationId="{65E7BA3F-4DEF-D813-D16B-141F2D841696}"/>
          </ac:grpSpMkLst>
        </pc:grpChg>
        <pc:grpChg chg="mod">
          <ac:chgData name="Peter Arner" userId="3fe2d872-2352-4a38-a10b-f5d5b2230715" providerId="ADAL" clId="{E0209236-D0DA-46AC-9428-03F54B6E0F0E}" dt="2024-12-10T14:29:33.354" v="2" actId="164"/>
          <ac:grpSpMkLst>
            <pc:docMk/>
            <pc:sldMk cId="1707854392" sldId="256"/>
            <ac:grpSpMk id="14" creationId="{B4DAF1E4-C78F-B67C-B3FD-A6110CECA50B}"/>
          </ac:grpSpMkLst>
        </pc:grpChg>
        <pc:grpChg chg="mod">
          <ac:chgData name="Peter Arner" userId="3fe2d872-2352-4a38-a10b-f5d5b2230715" providerId="ADAL" clId="{E0209236-D0DA-46AC-9428-03F54B6E0F0E}" dt="2024-12-10T14:43:28.489" v="110" actId="164"/>
          <ac:grpSpMkLst>
            <pc:docMk/>
            <pc:sldMk cId="1707854392" sldId="256"/>
            <ac:grpSpMk id="16" creationId="{DF181D5A-B4D2-EE0B-E6A5-96652E70B8A8}"/>
          </ac:grpSpMkLst>
        </pc:grpChg>
        <pc:grpChg chg="mod">
          <ac:chgData name="Peter Arner" userId="3fe2d872-2352-4a38-a10b-f5d5b2230715" providerId="ADAL" clId="{E0209236-D0DA-46AC-9428-03F54B6E0F0E}" dt="2024-12-10T14:43:28.489" v="110" actId="164"/>
          <ac:grpSpMkLst>
            <pc:docMk/>
            <pc:sldMk cId="1707854392" sldId="256"/>
            <ac:grpSpMk id="19" creationId="{38081BC6-5E8E-53DB-0AA3-DEE4C6E19501}"/>
          </ac:grpSpMkLst>
        </pc:grpChg>
        <pc:grpChg chg="mod">
          <ac:chgData name="Peter Arner" userId="3fe2d872-2352-4a38-a10b-f5d5b2230715" providerId="ADAL" clId="{E0209236-D0DA-46AC-9428-03F54B6E0F0E}" dt="2024-12-10T14:43:28.489" v="110" actId="164"/>
          <ac:grpSpMkLst>
            <pc:docMk/>
            <pc:sldMk cId="1707854392" sldId="256"/>
            <ac:grpSpMk id="22" creationId="{FADB5EEA-8A26-58FE-DA0A-AE275BBB9039}"/>
          </ac:grpSpMkLst>
        </pc:grpChg>
        <pc:grpChg chg="add mod">
          <ac:chgData name="Peter Arner" userId="3fe2d872-2352-4a38-a10b-f5d5b2230715" providerId="ADAL" clId="{E0209236-D0DA-46AC-9428-03F54B6E0F0E}" dt="2024-12-10T14:55:40.957" v="127" actId="1076"/>
          <ac:grpSpMkLst>
            <pc:docMk/>
            <pc:sldMk cId="1707854392" sldId="256"/>
            <ac:grpSpMk id="30" creationId="{D6381064-FC2E-E2FF-A168-C9165CD2A57D}"/>
          </ac:grpSpMkLst>
        </pc:grpChg>
        <pc:grpChg chg="add mod">
          <ac:chgData name="Peter Arner" userId="3fe2d872-2352-4a38-a10b-f5d5b2230715" providerId="ADAL" clId="{E0209236-D0DA-46AC-9428-03F54B6E0F0E}" dt="2024-12-10T14:58:30.608" v="199" actId="164"/>
          <ac:grpSpMkLst>
            <pc:docMk/>
            <pc:sldMk cId="1707854392" sldId="256"/>
            <ac:grpSpMk id="35" creationId="{BEB78730-CC5E-4735-D931-757DB3A81B1A}"/>
          </ac:grpSpMkLst>
        </pc:grpChg>
        <pc:cxnChg chg="mod">
          <ac:chgData name="Peter Arner" userId="3fe2d872-2352-4a38-a10b-f5d5b2230715" providerId="ADAL" clId="{E0209236-D0DA-46AC-9428-03F54B6E0F0E}" dt="2024-12-10T14:52:07.564" v="114" actId="14100"/>
          <ac:cxnSpMkLst>
            <pc:docMk/>
            <pc:sldMk cId="1707854392" sldId="256"/>
            <ac:cxnSpMk id="27" creationId="{7148E0C8-CE82-01AA-AACD-C3DDABA4BEA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03089ED-A8F9-356C-C4F3-E8DF66D319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3C3AD2A9-04FC-785F-AC23-A07523455D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F5FB953-90EC-3E58-FBCC-3A34036AC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6B0CB81-C389-5B7E-BCC9-8289EEEFB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7C746D1-BEFD-0E9F-3552-EF91840E2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672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A9B6C1B-CCF2-07E3-8612-B1DAFE84C6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9435A03-864C-904C-4B65-9FE23E5D4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FBC592A-47EF-206C-8F35-059EE8EEF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DE4F417-C5FF-4F30-D232-5CFAE4E92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028DAE4-FD1E-FEC4-A717-0FDEF9132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4593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12E4067C-7CCB-9449-19A2-6739235456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4CD44645-4CA6-E439-9A57-7D7F8DD61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39A5AA2-B95D-EB81-15E5-752DC3283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5893CAB-0785-1FEA-0640-99BDE9AAD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9A177E1-DEB7-C25C-F4C7-D9E6E0973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8842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3E1BD14-27B2-EF05-2E28-11B0E0030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1F897A4-E24B-9EEC-20B4-7869CC304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824CF7C-55FE-6354-54A8-E1BCC7BF8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2664CCA-B1AE-009E-3ED3-0FFC55199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AF58A3E-748B-5937-B5DE-3B08776F9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52975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3EF648F-FA3E-9790-24FE-6FFD728609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0D2788F-FBD7-EB13-DF6D-E03A30085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CF0D7A6-B4AB-4669-A0E4-D10BC3D6F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2C13A34-BFAB-0F65-89EA-A8E8FD40F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6022759-7680-67FB-229B-15EC3C50C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3056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6D6287C-F4C3-F337-4FBD-529457224F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EF573C11-D973-25EE-CF24-0C03692F33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61E2C38-281B-03CC-B540-8EDE6D1AE8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B9E3BFB9-028D-73D6-5E4F-7116114E5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CD9AA14C-6128-8624-87F7-180AB45D8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58F3BD0-2719-E4E9-C83D-02547855A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06709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EE838D5-8F84-5AE7-90D9-A0FA9F9EC5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DDAC500-5656-E0EE-2815-62D0F78FE1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48F9382-D026-8B8F-90A6-FA0D4516F3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B425B99A-1D50-C806-2573-384A6C032E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B36EC949-0244-E544-B358-94352725F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F513072F-CB51-38EE-D847-3AFDAB8F4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CCE754EC-5CC6-FBBA-7146-11AE0AF17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AF01033B-072B-AEC1-D40B-A1FE8884B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37601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5209CF7-F364-4B6B-A0D9-FF8375F05F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7E9CBCFF-B0FE-1B4A-6A91-61D9E027E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49C81B5C-664D-01FE-A67A-3447F1863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EB432E06-5AB1-3DC8-0F1B-1B40A5025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0536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63AF587A-CF99-7B1B-06F5-964190C8A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B808B647-6155-A1E7-64AE-437093EC1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3841C243-F3DF-5F5E-7B99-D596F56DF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6255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C69876E-BE72-8ADA-E7CB-0CA266E1B1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7B01A30-ED56-4A02-63F2-64DA465F1B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A3D1E0D3-E2C2-3EC5-0377-5D6FD5ECC1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0E5A3E3-996C-9B14-80C5-41A778BFE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1B75176-541F-1115-4C7E-09EBA0D92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4FAA759-6395-FE0C-4497-A7452BA97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24599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9554FD5-EA06-345E-FB4B-515E095644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B31ED666-AB90-D191-2781-CC0BE1E546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8C5E67CD-35A9-8B15-6949-6ED6F942DE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F02EE8AD-7966-12EC-0F0C-C1ED60D15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F7C9849-4A3D-1964-6CB4-61BD2D761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82A3D14-F33A-0654-9BC4-5E9160A8B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11370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419F66B8-1E7B-4CDA-DB10-04C99A305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0571B9F-D295-F233-4910-699B9761B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303CD60-73AE-DDCE-0510-3099F8F5C3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6E5565-EEDA-4440-AB1D-423F0F26593C}" type="datetimeFigureOut">
              <a:rPr lang="sv-SE" smtClean="0"/>
              <a:t>2025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E94E2A5-47E7-B0FF-23E2-A3AB425B78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266231F-7AE6-21DF-99F3-907AD770AF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1065E2-51D2-4AAD-8605-5ED5CA62F79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69204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>
            <a:extLst>
              <a:ext uri="{FF2B5EF4-FFF2-40B4-BE49-F238E27FC236}">
                <a16:creationId xmlns:a16="http://schemas.microsoft.com/office/drawing/2014/main" id="{A1BD9681-7FD6-8199-6AF5-466741EFFEE2}"/>
              </a:ext>
            </a:extLst>
          </p:cNvPr>
          <p:cNvGrpSpPr/>
          <p:nvPr/>
        </p:nvGrpSpPr>
        <p:grpSpPr>
          <a:xfrm>
            <a:off x="385133" y="335315"/>
            <a:ext cx="2151210" cy="4351344"/>
            <a:chOff x="1694914" y="199113"/>
            <a:chExt cx="2151210" cy="4351344"/>
          </a:xfrm>
        </p:grpSpPr>
        <p:grpSp>
          <p:nvGrpSpPr>
            <p:cNvPr id="12" name="Grupp 11">
              <a:extLst>
                <a:ext uri="{FF2B5EF4-FFF2-40B4-BE49-F238E27FC236}">
                  <a16:creationId xmlns:a16="http://schemas.microsoft.com/office/drawing/2014/main" id="{F3502025-4E0E-F060-B80A-64242423D791}"/>
                </a:ext>
              </a:extLst>
            </p:cNvPr>
            <p:cNvGrpSpPr/>
            <p:nvPr/>
          </p:nvGrpSpPr>
          <p:grpSpPr>
            <a:xfrm>
              <a:off x="1694914" y="969737"/>
              <a:ext cx="2140857" cy="1079585"/>
              <a:chOff x="1683657" y="105681"/>
              <a:chExt cx="2140857" cy="1079585"/>
            </a:xfrm>
          </p:grpSpPr>
          <p:sp>
            <p:nvSpPr>
              <p:cNvPr id="5" name="Rektangel 4">
                <a:extLst>
                  <a:ext uri="{FF2B5EF4-FFF2-40B4-BE49-F238E27FC236}">
                    <a16:creationId xmlns:a16="http://schemas.microsoft.com/office/drawing/2014/main" id="{0456044A-CB02-9EAD-E30D-CB6A0D02F48D}"/>
                  </a:ext>
                </a:extLst>
              </p:cNvPr>
              <p:cNvSpPr/>
              <p:nvPr/>
            </p:nvSpPr>
            <p:spPr>
              <a:xfrm>
                <a:off x="1683657" y="105681"/>
                <a:ext cx="2140857" cy="10795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  <p:sp>
            <p:nvSpPr>
              <p:cNvPr id="8" name="textruta 7">
                <a:extLst>
                  <a:ext uri="{FF2B5EF4-FFF2-40B4-BE49-F238E27FC236}">
                    <a16:creationId xmlns:a16="http://schemas.microsoft.com/office/drawing/2014/main" id="{9B4093C9-348C-A8F9-F08E-86AF502B8536}"/>
                  </a:ext>
                </a:extLst>
              </p:cNvPr>
              <p:cNvSpPr txBox="1"/>
              <p:nvPr/>
            </p:nvSpPr>
            <p:spPr>
              <a:xfrm>
                <a:off x="1907763" y="216660"/>
                <a:ext cx="1566454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014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011</a:t>
                </a:r>
              </a:p>
            </p:txBody>
          </p:sp>
        </p:grpSp>
        <p:grpSp>
          <p:nvGrpSpPr>
            <p:cNvPr id="13" name="Grupp 12">
              <a:extLst>
                <a:ext uri="{FF2B5EF4-FFF2-40B4-BE49-F238E27FC236}">
                  <a16:creationId xmlns:a16="http://schemas.microsoft.com/office/drawing/2014/main" id="{65E7BA3F-4DEF-D813-D16B-141F2D841696}"/>
                </a:ext>
              </a:extLst>
            </p:cNvPr>
            <p:cNvGrpSpPr/>
            <p:nvPr/>
          </p:nvGrpSpPr>
          <p:grpSpPr>
            <a:xfrm>
              <a:off x="1705266" y="2220304"/>
              <a:ext cx="2140857" cy="1079585"/>
              <a:chOff x="1734455" y="2118977"/>
              <a:chExt cx="2140857" cy="1079585"/>
            </a:xfrm>
          </p:grpSpPr>
          <p:sp>
            <p:nvSpPr>
              <p:cNvPr id="7" name="textruta 6">
                <a:extLst>
                  <a:ext uri="{FF2B5EF4-FFF2-40B4-BE49-F238E27FC236}">
                    <a16:creationId xmlns:a16="http://schemas.microsoft.com/office/drawing/2014/main" id="{25F7AB6B-339A-64D6-4706-F8762EF6CB72}"/>
                  </a:ext>
                </a:extLst>
              </p:cNvPr>
              <p:cNvSpPr txBox="1"/>
              <p:nvPr/>
            </p:nvSpPr>
            <p:spPr>
              <a:xfrm>
                <a:off x="1773991" y="2243807"/>
                <a:ext cx="2061783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lus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965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965</a:t>
                </a:r>
              </a:p>
            </p:txBody>
          </p:sp>
          <p:sp>
            <p:nvSpPr>
              <p:cNvPr id="10" name="Rektangel 9">
                <a:extLst>
                  <a:ext uri="{FF2B5EF4-FFF2-40B4-BE49-F238E27FC236}">
                    <a16:creationId xmlns:a16="http://schemas.microsoft.com/office/drawing/2014/main" id="{E2854D45-8498-5D84-81EF-6B9C81DD9BB3}"/>
                  </a:ext>
                </a:extLst>
              </p:cNvPr>
              <p:cNvSpPr/>
              <p:nvPr/>
            </p:nvSpPr>
            <p:spPr>
              <a:xfrm>
                <a:off x="1734455" y="2118977"/>
                <a:ext cx="2140857" cy="10795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</p:grpSp>
        <p:grpSp>
          <p:nvGrpSpPr>
            <p:cNvPr id="14" name="Grupp 13">
              <a:extLst>
                <a:ext uri="{FF2B5EF4-FFF2-40B4-BE49-F238E27FC236}">
                  <a16:creationId xmlns:a16="http://schemas.microsoft.com/office/drawing/2014/main" id="{B4DAF1E4-C78F-B67C-B3FD-A6110CECA50B}"/>
                </a:ext>
              </a:extLst>
            </p:cNvPr>
            <p:cNvGrpSpPr/>
            <p:nvPr/>
          </p:nvGrpSpPr>
          <p:grpSpPr>
            <a:xfrm>
              <a:off x="1705267" y="3470872"/>
              <a:ext cx="2140857" cy="1079585"/>
              <a:chOff x="1734455" y="3906072"/>
              <a:chExt cx="2140857" cy="1079585"/>
            </a:xfrm>
          </p:grpSpPr>
          <p:sp>
            <p:nvSpPr>
              <p:cNvPr id="9" name="textruta 8">
                <a:extLst>
                  <a:ext uri="{FF2B5EF4-FFF2-40B4-BE49-F238E27FC236}">
                    <a16:creationId xmlns:a16="http://schemas.microsoft.com/office/drawing/2014/main" id="{D30332D2-57AD-9DE7-F87E-3C8EA711874E}"/>
                  </a:ext>
                </a:extLst>
              </p:cNvPr>
              <p:cNvSpPr txBox="1"/>
              <p:nvPr/>
            </p:nvSpPr>
            <p:spPr>
              <a:xfrm>
                <a:off x="1948208" y="4030365"/>
                <a:ext cx="1608517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sceral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73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73</a:t>
                </a:r>
              </a:p>
            </p:txBody>
          </p:sp>
          <p:sp>
            <p:nvSpPr>
              <p:cNvPr id="11" name="Rektangel 10">
                <a:extLst>
                  <a:ext uri="{FF2B5EF4-FFF2-40B4-BE49-F238E27FC236}">
                    <a16:creationId xmlns:a16="http://schemas.microsoft.com/office/drawing/2014/main" id="{8A56FB78-1A5F-30A0-380B-692263F539C0}"/>
                  </a:ext>
                </a:extLst>
              </p:cNvPr>
              <p:cNvSpPr/>
              <p:nvPr/>
            </p:nvSpPr>
            <p:spPr>
              <a:xfrm>
                <a:off x="1734455" y="3906072"/>
                <a:ext cx="2140857" cy="10795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</p:grpSp>
        <p:sp>
          <p:nvSpPr>
            <p:cNvPr id="15" name="textruta 14">
              <a:extLst>
                <a:ext uri="{FF2B5EF4-FFF2-40B4-BE49-F238E27FC236}">
                  <a16:creationId xmlns:a16="http://schemas.microsoft.com/office/drawing/2014/main" id="{9658CC0C-4D37-EEA8-228B-A0AEEF93E32E}"/>
                </a:ext>
              </a:extLst>
            </p:cNvPr>
            <p:cNvSpPr txBox="1"/>
            <p:nvPr/>
          </p:nvSpPr>
          <p:spPr>
            <a:xfrm>
              <a:off x="1919020" y="199113"/>
              <a:ext cx="171335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RST EXAMINATION</a:t>
              </a:r>
              <a:b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ear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988 – 2016</a:t>
              </a:r>
            </a:p>
            <a:p>
              <a:pPr algn="ctr"/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014</a:t>
              </a:r>
            </a:p>
          </p:txBody>
        </p:sp>
      </p:grpSp>
      <p:grpSp>
        <p:nvGrpSpPr>
          <p:cNvPr id="30" name="Grupp 29">
            <a:extLst>
              <a:ext uri="{FF2B5EF4-FFF2-40B4-BE49-F238E27FC236}">
                <a16:creationId xmlns:a16="http://schemas.microsoft.com/office/drawing/2014/main" id="{D6381064-FC2E-E2FF-A168-C9165CD2A57D}"/>
              </a:ext>
            </a:extLst>
          </p:cNvPr>
          <p:cNvGrpSpPr/>
          <p:nvPr/>
        </p:nvGrpSpPr>
        <p:grpSpPr>
          <a:xfrm>
            <a:off x="5804073" y="282136"/>
            <a:ext cx="3117508" cy="4388337"/>
            <a:chOff x="7518472" y="37825"/>
            <a:chExt cx="3117508" cy="4388337"/>
          </a:xfrm>
        </p:grpSpPr>
        <p:grpSp>
          <p:nvGrpSpPr>
            <p:cNvPr id="16" name="Grupp 15">
              <a:extLst>
                <a:ext uri="{FF2B5EF4-FFF2-40B4-BE49-F238E27FC236}">
                  <a16:creationId xmlns:a16="http://schemas.microsoft.com/office/drawing/2014/main" id="{DF181D5A-B4D2-EE0B-E6A5-96652E70B8A8}"/>
                </a:ext>
              </a:extLst>
            </p:cNvPr>
            <p:cNvGrpSpPr/>
            <p:nvPr/>
          </p:nvGrpSpPr>
          <p:grpSpPr>
            <a:xfrm>
              <a:off x="7519942" y="745497"/>
              <a:ext cx="3105686" cy="1079585"/>
              <a:chOff x="1683657" y="105681"/>
              <a:chExt cx="2140857" cy="1079585"/>
            </a:xfrm>
          </p:grpSpPr>
          <p:sp>
            <p:nvSpPr>
              <p:cNvPr id="17" name="Rektangel 16">
                <a:extLst>
                  <a:ext uri="{FF2B5EF4-FFF2-40B4-BE49-F238E27FC236}">
                    <a16:creationId xmlns:a16="http://schemas.microsoft.com/office/drawing/2014/main" id="{895C258B-240C-E879-3E2B-1A2CAEA62AF1}"/>
                  </a:ext>
                </a:extLst>
              </p:cNvPr>
              <p:cNvSpPr/>
              <p:nvPr/>
            </p:nvSpPr>
            <p:spPr>
              <a:xfrm>
                <a:off x="1683657" y="105681"/>
                <a:ext cx="2140857" cy="10795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  <p:sp>
            <p:nvSpPr>
              <p:cNvPr id="18" name="textruta 17">
                <a:extLst>
                  <a:ext uri="{FF2B5EF4-FFF2-40B4-BE49-F238E27FC236}">
                    <a16:creationId xmlns:a16="http://schemas.microsoft.com/office/drawing/2014/main" id="{876EB3AB-C48E-8A4F-4490-F918C2C29525}"/>
                  </a:ext>
                </a:extLst>
              </p:cNvPr>
              <p:cNvSpPr txBox="1"/>
              <p:nvPr/>
            </p:nvSpPr>
            <p:spPr>
              <a:xfrm>
                <a:off x="1907763" y="141044"/>
                <a:ext cx="1620159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itial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81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 at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low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81</a:t>
                </a:r>
              </a:p>
            </p:txBody>
          </p:sp>
        </p:grpSp>
        <p:grpSp>
          <p:nvGrpSpPr>
            <p:cNvPr id="19" name="Grupp 18">
              <a:extLst>
                <a:ext uri="{FF2B5EF4-FFF2-40B4-BE49-F238E27FC236}">
                  <a16:creationId xmlns:a16="http://schemas.microsoft.com/office/drawing/2014/main" id="{38081BC6-5E8E-53DB-0AA3-DEE4C6E19501}"/>
                </a:ext>
              </a:extLst>
            </p:cNvPr>
            <p:cNvGrpSpPr/>
            <p:nvPr/>
          </p:nvGrpSpPr>
          <p:grpSpPr>
            <a:xfrm>
              <a:off x="7518472" y="1988931"/>
              <a:ext cx="3117508" cy="1079585"/>
              <a:chOff x="1756336" y="2118977"/>
              <a:chExt cx="2176718" cy="1079585"/>
            </a:xfrm>
          </p:grpSpPr>
          <p:sp>
            <p:nvSpPr>
              <p:cNvPr id="20" name="textruta 19">
                <a:extLst>
                  <a:ext uri="{FF2B5EF4-FFF2-40B4-BE49-F238E27FC236}">
                    <a16:creationId xmlns:a16="http://schemas.microsoft.com/office/drawing/2014/main" id="{565820A5-BF89-D550-DF3D-2DAA842767FD}"/>
                  </a:ext>
                </a:extLst>
              </p:cNvPr>
              <p:cNvSpPr txBox="1"/>
              <p:nvPr/>
            </p:nvSpPr>
            <p:spPr>
              <a:xfrm>
                <a:off x="1984358" y="2192494"/>
                <a:ext cx="1733949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itial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plus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74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 at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low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74</a:t>
                </a:r>
              </a:p>
            </p:txBody>
          </p:sp>
          <p:sp>
            <p:nvSpPr>
              <p:cNvPr id="21" name="Rektangel 20">
                <a:extLst>
                  <a:ext uri="{FF2B5EF4-FFF2-40B4-BE49-F238E27FC236}">
                    <a16:creationId xmlns:a16="http://schemas.microsoft.com/office/drawing/2014/main" id="{0E1F5F36-D9EC-16BD-30E1-F878D2F51D32}"/>
                  </a:ext>
                </a:extLst>
              </p:cNvPr>
              <p:cNvSpPr/>
              <p:nvPr/>
            </p:nvSpPr>
            <p:spPr>
              <a:xfrm>
                <a:off x="1756336" y="2118977"/>
                <a:ext cx="2176718" cy="10795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</p:grpSp>
        <p:grpSp>
          <p:nvGrpSpPr>
            <p:cNvPr id="22" name="Grupp 21">
              <a:extLst>
                <a:ext uri="{FF2B5EF4-FFF2-40B4-BE49-F238E27FC236}">
                  <a16:creationId xmlns:a16="http://schemas.microsoft.com/office/drawing/2014/main" id="{FADB5EEA-8A26-58FE-DA0A-AE275BBB9039}"/>
                </a:ext>
              </a:extLst>
            </p:cNvPr>
            <p:cNvGrpSpPr/>
            <p:nvPr/>
          </p:nvGrpSpPr>
          <p:grpSpPr>
            <a:xfrm>
              <a:off x="7518472" y="3356323"/>
              <a:ext cx="3117508" cy="1069839"/>
              <a:chOff x="1734452" y="3915818"/>
              <a:chExt cx="2176721" cy="1069839"/>
            </a:xfrm>
          </p:grpSpPr>
          <p:sp>
            <p:nvSpPr>
              <p:cNvPr id="23" name="textruta 22">
                <a:extLst>
                  <a:ext uri="{FF2B5EF4-FFF2-40B4-BE49-F238E27FC236}">
                    <a16:creationId xmlns:a16="http://schemas.microsoft.com/office/drawing/2014/main" id="{0F36B1A3-E864-1C0D-5937-F97B8E5881C1}"/>
                  </a:ext>
                </a:extLst>
              </p:cNvPr>
              <p:cNvSpPr txBox="1"/>
              <p:nvPr/>
            </p:nvSpPr>
            <p:spPr>
              <a:xfrm>
                <a:off x="1962474" y="3975055"/>
                <a:ext cx="1667915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itial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sceral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ipocyte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ze</a:t>
                </a:r>
                <a:endPara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56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BMI at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low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sv-SE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sv-SE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56</a:t>
                </a:r>
              </a:p>
            </p:txBody>
          </p:sp>
          <p:sp>
            <p:nvSpPr>
              <p:cNvPr id="24" name="Rektangel 23">
                <a:extLst>
                  <a:ext uri="{FF2B5EF4-FFF2-40B4-BE49-F238E27FC236}">
                    <a16:creationId xmlns:a16="http://schemas.microsoft.com/office/drawing/2014/main" id="{4B80FDA4-7D52-C85B-D4B8-2A1F5190083F}"/>
                  </a:ext>
                </a:extLst>
              </p:cNvPr>
              <p:cNvSpPr/>
              <p:nvPr/>
            </p:nvSpPr>
            <p:spPr>
              <a:xfrm>
                <a:off x="1734452" y="3915818"/>
                <a:ext cx="2176721" cy="106983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>
                  <a:noFill/>
                </a:endParaRPr>
              </a:p>
            </p:txBody>
          </p:sp>
        </p:grp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51390AE3-AAD6-F91D-C1A1-3054F04B916C}"/>
                </a:ext>
              </a:extLst>
            </p:cNvPr>
            <p:cNvSpPr txBox="1"/>
            <p:nvPr/>
          </p:nvSpPr>
          <p:spPr>
            <a:xfrm>
              <a:off x="7847099" y="37825"/>
              <a:ext cx="191167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 EXAMINATION</a:t>
              </a:r>
              <a:b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ear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018 – 2021</a:t>
              </a:r>
            </a:p>
            <a:p>
              <a:pPr algn="ctr"/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81</a:t>
              </a:r>
            </a:p>
          </p:txBody>
        </p:sp>
      </p:grpSp>
      <p:cxnSp>
        <p:nvCxnSpPr>
          <p:cNvPr id="27" name="Rak pilkoppling 26">
            <a:extLst>
              <a:ext uri="{FF2B5EF4-FFF2-40B4-BE49-F238E27FC236}">
                <a16:creationId xmlns:a16="http://schemas.microsoft.com/office/drawing/2014/main" id="{7148E0C8-CE82-01AA-AACD-C3DDABA4BEA0}"/>
              </a:ext>
            </a:extLst>
          </p:cNvPr>
          <p:cNvCxnSpPr>
            <a:cxnSpLocks/>
          </p:cNvCxnSpPr>
          <p:nvPr/>
        </p:nvCxnSpPr>
        <p:spPr>
          <a:xfrm>
            <a:off x="2645229" y="2807094"/>
            <a:ext cx="2830285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ruta 27">
            <a:extLst>
              <a:ext uri="{FF2B5EF4-FFF2-40B4-BE49-F238E27FC236}">
                <a16:creationId xmlns:a16="http://schemas.microsoft.com/office/drawing/2014/main" id="{6EA6837D-5F57-2B05-763E-24B6CBDC2916}"/>
              </a:ext>
            </a:extLst>
          </p:cNvPr>
          <p:cNvSpPr txBox="1"/>
          <p:nvPr/>
        </p:nvSpPr>
        <p:spPr>
          <a:xfrm>
            <a:off x="3135691" y="2219578"/>
            <a:ext cx="1721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DURATION</a:t>
            </a:r>
          </a:p>
          <a:p>
            <a:pPr algn="ctr"/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ktangel 25">
            <a:extLst>
              <a:ext uri="{FF2B5EF4-FFF2-40B4-BE49-F238E27FC236}">
                <a16:creationId xmlns:a16="http://schemas.microsoft.com/office/drawing/2014/main" id="{399A0715-4849-E7C1-500A-40166A096396}"/>
              </a:ext>
            </a:extLst>
          </p:cNvPr>
          <p:cNvSpPr/>
          <p:nvPr/>
        </p:nvSpPr>
        <p:spPr>
          <a:xfrm>
            <a:off x="2979673" y="2944210"/>
            <a:ext cx="2140857" cy="131284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textruta 28">
            <a:extLst>
              <a:ext uri="{FF2B5EF4-FFF2-40B4-BE49-F238E27FC236}">
                <a16:creationId xmlns:a16="http://schemas.microsoft.com/office/drawing/2014/main" id="{2059A457-8E37-0CA0-6481-F6A2F6EC99E1}"/>
              </a:ext>
            </a:extLst>
          </p:cNvPr>
          <p:cNvSpPr txBox="1"/>
          <p:nvPr/>
        </p:nvSpPr>
        <p:spPr>
          <a:xfrm flipH="1">
            <a:off x="3140701" y="3056144"/>
            <a:ext cx="189822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ntervention n=164</a:t>
            </a:r>
          </a:p>
          <a:p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i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f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yle n=48</a:t>
            </a:r>
          </a:p>
          <a:p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iatric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gery</a:t>
            </a:r>
            <a:r>
              <a:rPr lang="sv-SE" sz="1200">
                <a:latin typeface="Times New Roman" panose="02020603050405020304" pitchFamily="18" charset="0"/>
                <a:cs typeface="Times New Roman" panose="02020603050405020304" pitchFamily="18" charset="0"/>
              </a:rPr>
              <a:t> n=69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Höger klammerparentes 31">
            <a:extLst>
              <a:ext uri="{FF2B5EF4-FFF2-40B4-BE49-F238E27FC236}">
                <a16:creationId xmlns:a16="http://schemas.microsoft.com/office/drawing/2014/main" id="{6421E6EA-5E8F-E9C4-94E2-13027DC024CE}"/>
              </a:ext>
            </a:extLst>
          </p:cNvPr>
          <p:cNvSpPr/>
          <p:nvPr/>
        </p:nvSpPr>
        <p:spPr>
          <a:xfrm>
            <a:off x="8911229" y="1433280"/>
            <a:ext cx="595303" cy="274280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grpSp>
        <p:nvGrpSpPr>
          <p:cNvPr id="35" name="Grupp 34">
            <a:extLst>
              <a:ext uri="{FF2B5EF4-FFF2-40B4-BE49-F238E27FC236}">
                <a16:creationId xmlns:a16="http://schemas.microsoft.com/office/drawing/2014/main" id="{BEB78730-CC5E-4735-D931-757DB3A81B1A}"/>
              </a:ext>
            </a:extLst>
          </p:cNvPr>
          <p:cNvGrpSpPr/>
          <p:nvPr/>
        </p:nvGrpSpPr>
        <p:grpSpPr>
          <a:xfrm>
            <a:off x="9699655" y="2139882"/>
            <a:ext cx="1695485" cy="1430210"/>
            <a:chOff x="9699655" y="2139882"/>
            <a:chExt cx="1695485" cy="1430210"/>
          </a:xfrm>
        </p:grpSpPr>
        <p:sp>
          <p:nvSpPr>
            <p:cNvPr id="33" name="Rektangel 32">
              <a:extLst>
                <a:ext uri="{FF2B5EF4-FFF2-40B4-BE49-F238E27FC236}">
                  <a16:creationId xmlns:a16="http://schemas.microsoft.com/office/drawing/2014/main" id="{D7B2BB63-139D-529B-64C7-85003875B96F}"/>
                </a:ext>
              </a:extLst>
            </p:cNvPr>
            <p:cNvSpPr/>
            <p:nvPr/>
          </p:nvSpPr>
          <p:spPr>
            <a:xfrm>
              <a:off x="9699655" y="2139882"/>
              <a:ext cx="1695485" cy="143021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4" name="textruta 33">
              <a:extLst>
                <a:ext uri="{FF2B5EF4-FFF2-40B4-BE49-F238E27FC236}">
                  <a16:creationId xmlns:a16="http://schemas.microsoft.com/office/drawing/2014/main" id="{D87CDE1E-0661-3DC5-BD8F-01E3438A47FC}"/>
                </a:ext>
              </a:extLst>
            </p:cNvPr>
            <p:cNvSpPr txBox="1"/>
            <p:nvPr/>
          </p:nvSpPr>
          <p:spPr>
            <a:xfrm>
              <a:off x="9808252" y="2296133"/>
              <a:ext cx="1478290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uestionnaire</a:t>
              </a:r>
              <a:endParaRPr lang="sv-SE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81</a:t>
              </a:r>
            </a:p>
            <a:p>
              <a:endParaRPr lang="sv-SE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inical examination</a:t>
              </a:r>
            </a:p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83</a:t>
              </a:r>
            </a:p>
            <a:p>
              <a:endParaRPr lang="sv-SE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07854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</TotalTime>
  <Words>144</Words>
  <Application>Microsoft Office PowerPoint</Application>
  <PresentationFormat>Bredbild</PresentationFormat>
  <Paragraphs>40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eter Arner</dc:creator>
  <cp:lastModifiedBy>Daniel P Andersson</cp:lastModifiedBy>
  <cp:revision>1</cp:revision>
  <dcterms:created xsi:type="dcterms:W3CDTF">2024-12-04T11:23:08Z</dcterms:created>
  <dcterms:modified xsi:type="dcterms:W3CDTF">2025-01-22T13:26:44Z</dcterms:modified>
</cp:coreProperties>
</file>